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3" r:id="rId2"/>
    <p:sldId id="274" r:id="rId3"/>
    <p:sldId id="275" r:id="rId4"/>
    <p:sldId id="280" r:id="rId5"/>
    <p:sldId id="277" r:id="rId6"/>
    <p:sldId id="281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oN User" initials="UoN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302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337217-7731-4562-A848-3571C3426F21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F68872-3E6B-4E5D-BB26-06AA3B3AB4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26448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7172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50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4776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376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323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3226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5539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109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537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4318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5010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0742F2-036C-4466-AA25-EFD39B76E8DA}" type="datetimeFigureOut">
              <a:rPr lang="en-GB" smtClean="0"/>
              <a:t>18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D2A7C-8381-498F-957D-3C6CAE33BF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424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20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2448" y="657200"/>
            <a:ext cx="4572000" cy="457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2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657200"/>
            <a:ext cx="3429000" cy="457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755576" y="5805264"/>
            <a:ext cx="788436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ep-wis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discriminant analysi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using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variate set of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6 root morphology traits. (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Specificity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ot showing th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roportion of genotypes of each ‘crop habit’ correctly allocated to each group, at each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ep of th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discriminant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; (B) discriminatio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lot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raw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o represent th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of ‘crop habits’ i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wo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mensional variance space. ‘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op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abit’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eans (X),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95% confidenc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ircles (circles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nd group polygons enclosing all units for each crop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abit are indicated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820342" y="4952201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dirty="0"/>
          </a:p>
        </p:txBody>
      </p:sp>
      <p:sp>
        <p:nvSpPr>
          <p:cNvPr id="15" name="Rectangle 14"/>
          <p:cNvSpPr/>
          <p:nvPr/>
        </p:nvSpPr>
        <p:spPr>
          <a:xfrm>
            <a:off x="4348734" y="4952201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dirty="0"/>
          </a:p>
        </p:txBody>
      </p:sp>
      <p:sp>
        <p:nvSpPr>
          <p:cNvPr id="9" name="Rectangle 8"/>
          <p:cNvSpPr/>
          <p:nvPr/>
        </p:nvSpPr>
        <p:spPr>
          <a:xfrm>
            <a:off x="2915816" y="188640"/>
            <a:ext cx="2813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s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43214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2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657200"/>
            <a:ext cx="3429000" cy="457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2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0826" y="657200"/>
            <a:ext cx="4572000" cy="457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tangle 9"/>
          <p:cNvSpPr/>
          <p:nvPr/>
        </p:nvSpPr>
        <p:spPr>
          <a:xfrm>
            <a:off x="820342" y="4952201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dirty="0"/>
          </a:p>
        </p:txBody>
      </p:sp>
      <p:sp>
        <p:nvSpPr>
          <p:cNvPr id="11" name="Rectangle 10"/>
          <p:cNvSpPr/>
          <p:nvPr/>
        </p:nvSpPr>
        <p:spPr>
          <a:xfrm>
            <a:off x="4348734" y="4952201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755576" y="5805264"/>
            <a:ext cx="788436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ep-wis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discriminant analysi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using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variate set of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1 leaf mineral composition traits. (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Specificity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ot showing th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roportion of genotypes of each ‘crop habit’ correctly allocated to each group, at each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ep of th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discriminant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; (B) discriminatio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lot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raw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o represent th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of ‘crop habits’ i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wo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mensional variance space. ‘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op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abit’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eans (X),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95% confidenc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ircles (circles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nd group polygons enclosing all units for each crop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abit are indicated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56884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2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657200"/>
            <a:ext cx="3429000" cy="457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2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2448" y="657200"/>
            <a:ext cx="4572000" cy="457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tangle 9"/>
          <p:cNvSpPr/>
          <p:nvPr/>
        </p:nvSpPr>
        <p:spPr>
          <a:xfrm>
            <a:off x="820342" y="4952201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dirty="0"/>
          </a:p>
        </p:txBody>
      </p:sp>
      <p:sp>
        <p:nvSpPr>
          <p:cNvPr id="11" name="Rectangle 10"/>
          <p:cNvSpPr/>
          <p:nvPr/>
        </p:nvSpPr>
        <p:spPr>
          <a:xfrm>
            <a:off x="4348734" y="4952201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755576" y="5805264"/>
            <a:ext cx="788436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ep-wis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discriminant analysi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using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variate set of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5 seed mineral composition traits. (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Specificity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ot showing th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roportion of genotypes of each ‘crop habit’ correctly allocated to each group, at each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ep of th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discriminant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; (B) discriminatio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lot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raw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o represent th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of ‘crop habits’ i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wo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mensional variance space. ‘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op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abit’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eans (X),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95% confidenc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ircles (circles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nd group polygons enclosing all units for each crop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abit are indicated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475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71" t="5848" r="4664" b="6510"/>
          <a:stretch/>
        </p:blipFill>
        <p:spPr bwMode="auto">
          <a:xfrm>
            <a:off x="236693" y="949508"/>
            <a:ext cx="3615228" cy="46391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755576" y="5805264"/>
            <a:ext cx="788436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4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ep-wis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discriminant analysi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using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variate set of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013 TSW and 2014 seed yield traits. (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Specificity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ot showing th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roportion of genotypes of each ‘crop habit’ correctly allocated to each group, at each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ep of th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discriminant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; (B) discriminatio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lot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raw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o represent th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of ‘crop habits’ i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wo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mensional variance space. ‘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op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abit’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eans (X),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95% confidenc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ircles (circles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nd group polygons enclosing all units for each crop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abit are indicated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323528" y="5439906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dirty="0"/>
          </a:p>
        </p:txBody>
      </p:sp>
      <p:sp>
        <p:nvSpPr>
          <p:cNvPr id="9" name="Rectangle 8"/>
          <p:cNvSpPr/>
          <p:nvPr/>
        </p:nvSpPr>
        <p:spPr>
          <a:xfrm>
            <a:off x="4174974" y="5373216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dirty="0"/>
          </a:p>
        </p:txBody>
      </p:sp>
      <p:pic>
        <p:nvPicPr>
          <p:cNvPr id="1433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87" t="6841" r="5806" b="6498"/>
          <a:stretch/>
        </p:blipFill>
        <p:spPr bwMode="auto">
          <a:xfrm>
            <a:off x="3914300" y="764274"/>
            <a:ext cx="4978180" cy="49526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3087130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1309752"/>
              </p:ext>
            </p:extLst>
          </p:nvPr>
        </p:nvGraphicFramePr>
        <p:xfrm>
          <a:off x="1475656" y="188640"/>
          <a:ext cx="5759450" cy="5305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31" name="SPW 11.0 Graph" r:id="rId3" imgW="5760000" imgH="5305680" progId="SigmaPlotGraphicObject.10">
                  <p:embed/>
                </p:oleObj>
              </mc:Choice>
              <mc:Fallback>
                <p:oleObj name="SPW 11.0 Graph" r:id="rId3" imgW="5760000" imgH="5305680" progId="SigmaPlotGraphicObject.1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75656" y="188640"/>
                        <a:ext cx="5759450" cy="5305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39552" y="5949280"/>
            <a:ext cx="828589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5.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2014 seed yield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Data are means of up to 320 genotypes, including winter OSR (n=142), spring OSR (n=124),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semiwinter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OSR (n=7), winter fodder (n=14) and swede (n=33) habits. Boxes represent the mid two quartiles with the median drawn; whiskers are the 95% confidence limits plu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tremes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4101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1965375"/>
              </p:ext>
            </p:extLst>
          </p:nvPr>
        </p:nvGraphicFramePr>
        <p:xfrm>
          <a:off x="1907704" y="692696"/>
          <a:ext cx="5230813" cy="4268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42" name="SPW 11.0 Graph" r:id="rId3" imgW="5230800" imgH="4268880" progId="SigmaPlotGraphicObject.10">
                  <p:embed/>
                </p:oleObj>
              </mc:Choice>
              <mc:Fallback>
                <p:oleObj name="SPW 11.0 Graph" r:id="rId3" imgW="5230800" imgH="4268880" progId="SigmaPlotGraphicObject.1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07704" y="692696"/>
                        <a:ext cx="5230813" cy="4268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39552" y="5949280"/>
            <a:ext cx="828589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ousand seed weight of 2013 seed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Data are means of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84 winter OSR genotypes from different release periods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oxes represent the mid two quartiles with the median drawn; whiskers are the 95% confidence limits plu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tremes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86483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46</TotalTime>
  <Words>510</Words>
  <Application>Microsoft Office PowerPoint</Application>
  <PresentationFormat>On-screen Show (4:3)</PresentationFormat>
  <Paragraphs>15</Paragraphs>
  <Slides>6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SPW 11.0 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</dc:creator>
  <cp:lastModifiedBy>UoN User</cp:lastModifiedBy>
  <cp:revision>127</cp:revision>
  <dcterms:created xsi:type="dcterms:W3CDTF">2015-07-08T16:11:11Z</dcterms:created>
  <dcterms:modified xsi:type="dcterms:W3CDTF">2016-05-18T09:54:05Z</dcterms:modified>
</cp:coreProperties>
</file>